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9CD12-CD45-4E87-8D74-8A2BFC0A79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479A5-CA7C-42E5-A944-2F686535E9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9E51D-AADC-43D6-BF0C-239851BB5E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3628F-2647-444D-AC24-D480615FDA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1D50CF-ED30-4085-9176-70649E712F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126D84-502F-4B84-A419-04701CF133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1A7CAD-2E74-414A-9CC5-C4488E6A6F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695156-8D3B-454D-9E27-B30C4D9374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34AA1-5B33-4815-81E2-7F06D5D33C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BECAC2-2449-4808-87AD-FA0B9065D3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6B4D0-4AAA-49E1-A3C3-FF310EED6C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7D3BE-F7DB-4113-BAA5-A6F0B949DE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9841CC-35F5-4641-816C-D8AE8DCEBBA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36640" y="684360"/>
            <a:ext cx="4897440" cy="7603200"/>
            <a:chOff x="836640" y="684360"/>
            <a:chExt cx="4897440" cy="760320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1143000" y="969840"/>
              <a:ext cx="4591080" cy="3244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1681200" y="1406160"/>
              <a:ext cx="82224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ellulose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5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ynth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855800" y="1199880"/>
              <a:ext cx="539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6-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212840" y="1555560"/>
              <a:ext cx="880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Pectine ester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270080" y="1855440"/>
              <a:ext cx="95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Modific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101680" y="1685520"/>
              <a:ext cx="1079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Pectate lyases / polygalacturonases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077920" y="2358720"/>
              <a:ext cx="60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Lip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969920" y="2097000"/>
              <a:ext cx="11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ACP-desatur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662200" y="2222280"/>
              <a:ext cx="735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Glyoxylat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155680" y="4228920"/>
              <a:ext cx="738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900" spc="-1" strike="noStrike">
                  <a:solidFill>
                    <a:srgbClr val="000000"/>
                  </a:solidFill>
                  <a:latin typeface="Arial"/>
                </a:rPr>
                <a:t>synthesi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379680" y="4228920"/>
              <a:ext cx="1025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900" spc="-1" strike="noStrike">
                  <a:solidFill>
                    <a:srgbClr val="000000"/>
                  </a:solidFill>
                  <a:latin typeface="Arial"/>
                </a:rPr>
                <a:t>breakdow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" descr=""/>
            <p:cNvPicPr/>
            <p:nvPr/>
          </p:nvPicPr>
          <p:blipFill>
            <a:blip r:embed="rId2"/>
            <a:stretch/>
          </p:blipFill>
          <p:spPr>
            <a:xfrm>
              <a:off x="1136520" y="4657320"/>
              <a:ext cx="4591080" cy="3452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"/>
            <p:cNvSpPr/>
            <p:nvPr/>
          </p:nvSpPr>
          <p:spPr>
            <a:xfrm>
              <a:off x="1671480" y="5122440"/>
              <a:ext cx="959040" cy="27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ellulose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5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ynth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855800" y="4910040"/>
              <a:ext cx="41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6-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239840" y="4968720"/>
              <a:ext cx="615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Cell wall protei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184400" y="5289120"/>
              <a:ext cx="880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Pectine ester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263600" y="5611680"/>
              <a:ext cx="83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Modifica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028960" y="5445000"/>
              <a:ext cx="1081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Pectate lyases / polygalacturonases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071800" y="6138720"/>
              <a:ext cx="60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Lip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741320" y="5860800"/>
              <a:ext cx="110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ACP-desatur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665440" y="5997240"/>
              <a:ext cx="804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Glyoxylat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149560" y="8056440"/>
              <a:ext cx="815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900" spc="-1" strike="noStrike">
                  <a:solidFill>
                    <a:srgbClr val="000000"/>
                  </a:solidFill>
                  <a:latin typeface="Arial"/>
                </a:rPr>
                <a:t>synthesi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373560" y="8048520"/>
              <a:ext cx="960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900" spc="-1" strike="noStrike">
                  <a:solidFill>
                    <a:srgbClr val="000000"/>
                  </a:solidFill>
                  <a:latin typeface="Arial"/>
                </a:rPr>
                <a:t>breakdow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849240" y="684360"/>
              <a:ext cx="405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836640" y="4416120"/>
              <a:ext cx="426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249200" y="1244160"/>
              <a:ext cx="615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Cell wall protei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7T13:37:03Z</dcterms:created>
  <dc:creator>ITB</dc:creator>
  <dc:description/>
  <dc:language>en-US</dc:language>
  <cp:lastModifiedBy>ITB</cp:lastModifiedBy>
  <dcterms:modified xsi:type="dcterms:W3CDTF">2011-03-07T15:56:36Z</dcterms:modified>
  <cp:revision>16</cp:revision>
  <dc:subject/>
  <dc:title>Folie 1</dc:title>
</cp:coreProperties>
</file>